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9"/>
  </p:notesMasterIdLst>
  <p:handoutMasterIdLst>
    <p:handoutMasterId r:id="rId10"/>
  </p:handoutMasterIdLst>
  <p:sldIdLst>
    <p:sldId id="298" r:id="rId2"/>
    <p:sldId id="304" r:id="rId3"/>
    <p:sldId id="303" r:id="rId4"/>
    <p:sldId id="307" r:id="rId5"/>
    <p:sldId id="302" r:id="rId6"/>
    <p:sldId id="306" r:id="rId7"/>
    <p:sldId id="305" r:id="rId8"/>
  </p:sldIdLst>
  <p:sldSz cx="6858000" cy="9906000" type="A4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233" userDrawn="1">
          <p15:clr>
            <a:srgbClr val="A4A3A4"/>
          </p15:clr>
        </p15:guide>
        <p15:guide id="3" orient="horz" pos="194" userDrawn="1">
          <p15:clr>
            <a:srgbClr val="A4A3A4"/>
          </p15:clr>
        </p15:guide>
        <p15:guide id="4" pos="2682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27" userDrawn="1">
          <p15:clr>
            <a:srgbClr val="A4A3A4"/>
          </p15:clr>
        </p15:guide>
        <p15:guide id="2" pos="2141" userDrawn="1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0A0A5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スタイルなし/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495" autoAdjust="0"/>
    <p:restoredTop sz="86938" autoAdjust="0"/>
  </p:normalViewPr>
  <p:slideViewPr>
    <p:cSldViewPr snapToGrid="0">
      <p:cViewPr>
        <p:scale>
          <a:sx n="80" d="100"/>
          <a:sy n="80" d="100"/>
        </p:scale>
        <p:origin x="1264" y="144"/>
      </p:cViewPr>
      <p:guideLst>
        <p:guide orient="horz" pos="3233"/>
        <p:guide orient="horz" pos="194"/>
        <p:guide pos="2682"/>
      </p:guideLst>
    </p:cSldViewPr>
  </p:slideViewPr>
  <p:notesTextViewPr>
    <p:cViewPr>
      <p:scale>
        <a:sx n="105" d="100"/>
        <a:sy n="105" d="100"/>
      </p:scale>
      <p:origin x="0" y="0"/>
    </p:cViewPr>
  </p:notesTextViewPr>
  <p:notesViewPr>
    <p:cSldViewPr snapToGrid="0">
      <p:cViewPr varScale="1">
        <p:scale>
          <a:sx n="59" d="100"/>
          <a:sy n="59" d="100"/>
        </p:scale>
        <p:origin x="-1590" y="-96"/>
      </p:cViewPr>
      <p:guideLst>
        <p:guide orient="horz" pos="3127"/>
        <p:guide pos="2141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2" y="1"/>
            <a:ext cx="2945659" cy="496332"/>
          </a:xfrm>
          <a:prstGeom prst="rect">
            <a:avLst/>
          </a:prstGeom>
        </p:spPr>
        <p:txBody>
          <a:bodyPr vert="horz" lIns="91420" tIns="45712" rIns="91420" bIns="45712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quarter" idx="1"/>
          </p:nvPr>
        </p:nvSpPr>
        <p:spPr>
          <a:xfrm>
            <a:off x="3850444" y="1"/>
            <a:ext cx="2945659" cy="496332"/>
          </a:xfrm>
          <a:prstGeom prst="rect">
            <a:avLst/>
          </a:prstGeom>
        </p:spPr>
        <p:txBody>
          <a:bodyPr vert="horz" lIns="91420" tIns="45712" rIns="91420" bIns="45712" rtlCol="0"/>
          <a:lstStyle>
            <a:lvl1pPr algn="r">
              <a:defRPr sz="1200"/>
            </a:lvl1pPr>
          </a:lstStyle>
          <a:p>
            <a:fld id="{74DF9A50-66D6-484E-BD03-444752F699DC}" type="datetimeFigureOut">
              <a:rPr kumimoji="1" lang="ja-JP" altLang="en-US" smtClean="0"/>
              <a:pPr/>
              <a:t>2025/6/29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2"/>
          </p:nvPr>
        </p:nvSpPr>
        <p:spPr>
          <a:xfrm>
            <a:off x="2" y="9428584"/>
            <a:ext cx="2945659" cy="496332"/>
          </a:xfrm>
          <a:prstGeom prst="rect">
            <a:avLst/>
          </a:prstGeom>
        </p:spPr>
        <p:txBody>
          <a:bodyPr vert="horz" lIns="91420" tIns="45712" rIns="91420" bIns="45712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3"/>
          </p:nvPr>
        </p:nvSpPr>
        <p:spPr>
          <a:xfrm>
            <a:off x="3850444" y="9428584"/>
            <a:ext cx="2945659" cy="496332"/>
          </a:xfrm>
          <a:prstGeom prst="rect">
            <a:avLst/>
          </a:prstGeom>
        </p:spPr>
        <p:txBody>
          <a:bodyPr vert="horz" lIns="91420" tIns="45712" rIns="91420" bIns="45712" rtlCol="0" anchor="b"/>
          <a:lstStyle>
            <a:lvl1pPr algn="r">
              <a:defRPr sz="1200"/>
            </a:lvl1pPr>
          </a:lstStyle>
          <a:p>
            <a:fld id="{1386AA09-E500-4DFB-B7BE-AB81E2B24D8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326723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6400" cy="496888"/>
          </a:xfrm>
          <a:prstGeom prst="rect">
            <a:avLst/>
          </a:prstGeom>
        </p:spPr>
        <p:txBody>
          <a:bodyPr vert="horz" lIns="91420" tIns="45712" rIns="91420" bIns="45712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20" tIns="45712" rIns="91420" bIns="45712" rtlCol="0"/>
          <a:lstStyle>
            <a:lvl1pPr algn="r">
              <a:defRPr sz="1200"/>
            </a:lvl1pPr>
          </a:lstStyle>
          <a:p>
            <a:fld id="{AD530752-E8B3-A94A-97AA-E5D05BB982DA}" type="datetimeFigureOut">
              <a:rPr kumimoji="1" lang="ja-JP" altLang="en-US" smtClean="0"/>
              <a:t>2025/6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09788" y="744538"/>
            <a:ext cx="25781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20" tIns="45712" rIns="91420" bIns="45712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451" y="4714876"/>
            <a:ext cx="5438775" cy="4467225"/>
          </a:xfrm>
          <a:prstGeom prst="rect">
            <a:avLst/>
          </a:prstGeom>
        </p:spPr>
        <p:txBody>
          <a:bodyPr vert="horz" lIns="91420" tIns="45712" rIns="91420" bIns="45712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9428165"/>
            <a:ext cx="2946400" cy="496887"/>
          </a:xfrm>
          <a:prstGeom prst="rect">
            <a:avLst/>
          </a:prstGeom>
        </p:spPr>
        <p:txBody>
          <a:bodyPr vert="horz" lIns="91420" tIns="45712" rIns="91420" bIns="45712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49688" y="9428165"/>
            <a:ext cx="2946400" cy="496887"/>
          </a:xfrm>
          <a:prstGeom prst="rect">
            <a:avLst/>
          </a:prstGeom>
        </p:spPr>
        <p:txBody>
          <a:bodyPr vert="horz" lIns="91420" tIns="45712" rIns="91420" bIns="45712" rtlCol="0" anchor="b"/>
          <a:lstStyle>
            <a:lvl1pPr algn="r">
              <a:defRPr sz="1200"/>
            </a:lvl1pPr>
          </a:lstStyle>
          <a:p>
            <a:fld id="{E378EB05-9383-CC47-85C3-845F055827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32105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109788" y="744538"/>
            <a:ext cx="2578100" cy="3722687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78EB05-9383-CC47-85C3-845F0558273D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196989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C28061A-71DD-6EF9-A1CF-57626D29323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6580BE84-3F7C-6D8E-2CAC-2ECBF218554F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2109788" y="744538"/>
            <a:ext cx="2578100" cy="3722687"/>
          </a:xfrm>
        </p:spPr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727764CB-EA8A-7BF4-B50C-8825310ECB07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B5E5655A-06AD-FBA9-4402-958F5E875471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78EB05-9383-CC47-85C3-845F0558273D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938875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13104D4-1449-C043-EDDE-93D8CC4A1E1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E3925BA0-494F-E553-3AB5-07032C32A419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2109788" y="744538"/>
            <a:ext cx="2578100" cy="3722687"/>
          </a:xfrm>
        </p:spPr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3BA0F275-99F2-D06B-0000-0672F60CFEA8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C1314C4E-CB82-202A-6C30-28DAD6A2F254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78EB05-9383-CC47-85C3-845F0558273D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806338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C235501-6F9E-B041-88BE-A201E425119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1FA889EA-7C1B-DAE1-FAED-A97594552A98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2109788" y="744538"/>
            <a:ext cx="2578100" cy="3722687"/>
          </a:xfrm>
        </p:spPr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5673DFDF-412E-642D-9C6D-93BDAA5F659B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17C68FBB-A9F2-7CB4-0287-DABD1ADA4DFD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78EB05-9383-CC47-85C3-845F0558273D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830414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0A5E00A-4910-D80B-3015-AAD67955522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890CAF6D-EBF6-62C2-9E2F-035DDA08A670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2109788" y="744538"/>
            <a:ext cx="2578100" cy="3722687"/>
          </a:xfrm>
        </p:spPr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FE47473A-6343-07B4-50FA-CF401843D1F1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C8930EB1-2E31-9B4C-F464-BF111091056C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78EB05-9383-CC47-85C3-845F0558273D}" type="slidenum">
              <a:rPr kumimoji="1" lang="ja-JP" altLang="en-US" smtClean="0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317908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E1219DA-DDA3-2F5B-1734-DA08EABCFB8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3B82CAFB-71A4-4325-0D5B-E6280AE0E6C9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2109788" y="744538"/>
            <a:ext cx="2578100" cy="3722687"/>
          </a:xfrm>
        </p:spPr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CF3DC996-FA83-F44B-E72E-90553B18A82A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AF84ADF5-F29D-4530-3DB9-E2CA62DB8118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78EB05-9383-CC47-85C3-845F0558273D}" type="slidenum">
              <a:rPr kumimoji="1" lang="ja-JP" altLang="en-US" smtClean="0"/>
              <a:t>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2635855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6E85CCE-228D-5158-B344-257EE9FBDE1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EB2DEC4F-3D0D-17DD-F608-63E0C4739C53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2109788" y="744538"/>
            <a:ext cx="2578100" cy="3722687"/>
          </a:xfrm>
        </p:spPr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D0C04B2A-14BE-B4AE-8D91-1F587AB69377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029B48B-C198-A7BF-FE20-7776CAA73677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78EB05-9383-CC47-85C3-845F0558273D}" type="slidenum">
              <a:rPr kumimoji="1" lang="ja-JP" altLang="en-US" smtClean="0"/>
              <a:t>7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17417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31A974E-2B19-1B2C-D86C-D8923D596C4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9CA395C3-97C4-2641-C174-F1D309F7F59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DA8BB21-527C-F395-855F-1F0DE3D14A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A2246-C00B-4C5A-9A2C-9CDCB25C8912}" type="datetimeFigureOut">
              <a:rPr kumimoji="1" lang="ja-JP" altLang="en-US" smtClean="0"/>
              <a:pPr/>
              <a:t>2025/6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E232599-FCFD-4687-F7A0-EB2F767742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A1A210F-9F97-B23C-8D36-BA58C38CFF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8B6BA3-1420-4C02-9F04-ECB96141A80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04946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4A5996E-DCCC-B751-75B4-93F01E9D99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F198AFC-2AE7-1569-54B1-6B0BD75E865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31F8FDC-CA02-7B8B-E40B-270D7F1115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A2246-C00B-4C5A-9A2C-9CDCB25C8912}" type="datetimeFigureOut">
              <a:rPr kumimoji="1" lang="ja-JP" altLang="en-US" smtClean="0"/>
              <a:pPr/>
              <a:t>2025/6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8ADFA86-F158-FC98-78E8-CFA2797075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E134528-9583-C3A9-2770-2C08BA1521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8B6BA3-1420-4C02-9F04-ECB96141A80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14074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43FBF8FF-0A2C-94DD-4530-0EF1D74C11A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4689D7E-4D38-5965-EE61-C72E9B34153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0C433CA-547E-370F-2922-5971B378A5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A2246-C00B-4C5A-9A2C-9CDCB25C8912}" type="datetimeFigureOut">
              <a:rPr kumimoji="1" lang="ja-JP" altLang="en-US" smtClean="0"/>
              <a:pPr/>
              <a:t>2025/6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DE5A176-1991-BB16-03B5-063178FF9E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F1ABD9B-2092-779D-FD7D-920ACF7E81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8B6BA3-1420-4C02-9F04-ECB96141A80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65493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F4BD162-4E4A-33AF-7BBE-4B1F470356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F6F2CF8-46B8-28A8-33E4-3FD856D3E4A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343D42A-3789-6012-BE75-8FE5E97A87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A2246-C00B-4C5A-9A2C-9CDCB25C8912}" type="datetimeFigureOut">
              <a:rPr kumimoji="1" lang="ja-JP" altLang="en-US" smtClean="0"/>
              <a:pPr/>
              <a:t>2025/6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5AF3427-41A7-5EC8-3200-A5ED3FFB3D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2AD4180-2E5E-7EE6-87E7-09D83C9B4B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8B6BA3-1420-4C02-9F04-ECB96141A80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49684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29FD0DA-B12D-CC71-AAE6-38A902A658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9A2251E-61BD-1417-FAA7-2780496517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82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82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6BF2306-5C9F-3F16-F816-46E8B6B268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A2246-C00B-4C5A-9A2C-9CDCB25C8912}" type="datetimeFigureOut">
              <a:rPr kumimoji="1" lang="ja-JP" altLang="en-US" smtClean="0"/>
              <a:pPr/>
              <a:t>2025/6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8423B64-A3BE-17D0-23F3-F3BDF82784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B453928-41B3-3A3D-5055-219E590FDA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8B6BA3-1420-4C02-9F04-ECB96141A80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95652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B9A6BDD-F7D8-E6BC-041A-F171A03C87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7BDD833-3FF4-A99B-3844-C4DB2770EC8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2C6C7FF-EC3A-0639-28DD-B5738C5D809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359E0D1-F8E4-61FC-A152-29A87B16F7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A2246-C00B-4C5A-9A2C-9CDCB25C8912}" type="datetimeFigureOut">
              <a:rPr kumimoji="1" lang="ja-JP" altLang="en-US" smtClean="0"/>
              <a:pPr/>
              <a:t>2025/6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431DBEF-1283-0338-61EE-E411CE47B7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6ADE1DA-A8AD-C861-6986-DA27ACAF2F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8B6BA3-1420-4C02-9F04-ECB96141A80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67928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E3D064F-B218-9583-F42C-01CB3AA80E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9FDE3AB-98B0-9D7A-D06E-7D30FB31D2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1D905E7-8FB0-D616-A5EF-0E14E42911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16DA022F-73E6-8D9B-75C0-C05B4DB111B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8E2E420F-63FD-7334-F06E-A42B42B93BF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8F5AE345-F00E-0E2C-E055-70B166DAF5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A2246-C00B-4C5A-9A2C-9CDCB25C8912}" type="datetimeFigureOut">
              <a:rPr kumimoji="1" lang="ja-JP" altLang="en-US" smtClean="0"/>
              <a:pPr/>
              <a:t>2025/6/2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F56F9DFF-6633-95A8-D2C2-B4019EB261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FEDB432C-5CB7-B16B-9C84-CEA88DC678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8B6BA3-1420-4C02-9F04-ECB96141A80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85366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AC3A39F-500E-424F-2C08-28F35C75E8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88197C87-D5FE-98F2-6A7F-29644CEF94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A2246-C00B-4C5A-9A2C-9CDCB25C8912}" type="datetimeFigureOut">
              <a:rPr kumimoji="1" lang="ja-JP" altLang="en-US" smtClean="0"/>
              <a:pPr/>
              <a:t>2025/6/2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064C2D55-0473-4124-4A46-7A5A9B1B74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76029C04-41AF-297D-8EC4-F524147182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8B6BA3-1420-4C02-9F04-ECB96141A80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14766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B4629655-CEB3-7B9B-7971-32AFFFE387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A2246-C00B-4C5A-9A2C-9CDCB25C8912}" type="datetimeFigureOut">
              <a:rPr kumimoji="1" lang="ja-JP" altLang="en-US" smtClean="0"/>
              <a:pPr/>
              <a:t>2025/6/2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6FA91701-8329-899F-94AE-8B53E283C1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5F689C8-CC74-1C23-841E-A7EAD1BAE9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8B6BA3-1420-4C02-9F04-ECB96141A80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36270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527D350-3986-E34C-CFD2-EDA97A8511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D8BE0A4-CD97-8E25-63C9-CEC336A26D7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3C73D90-D0C5-4E7E-03D9-3712869F35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BB6BA86-F329-8EDF-0AE2-8C7A9A4A73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A2246-C00B-4C5A-9A2C-9CDCB25C8912}" type="datetimeFigureOut">
              <a:rPr kumimoji="1" lang="ja-JP" altLang="en-US" smtClean="0"/>
              <a:pPr/>
              <a:t>2025/6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E0B3889-7127-272E-DBBA-07F651D910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CF58F5B-E04E-13E7-9968-52F8509020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8B6BA3-1420-4C02-9F04-ECB96141A80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87211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3654C43-06C8-12B4-1107-7F50B47A87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DAD8990B-271B-206F-0427-710F850A04D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20185F0C-DD64-8193-85B4-0328DF300E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5714001-7AB4-F401-8B02-6167E22AE6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A2246-C00B-4C5A-9A2C-9CDCB25C8912}" type="datetimeFigureOut">
              <a:rPr kumimoji="1" lang="ja-JP" altLang="en-US" smtClean="0"/>
              <a:pPr/>
              <a:t>2025/6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0BAA10C-A145-5BEF-9124-38C14BCBFD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094032E-ED32-F021-5913-1B0AA71668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8B6BA3-1420-4C02-9F04-ECB96141A80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49812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8703F2A6-1E2A-BCE6-A58D-820B333B1C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8C3D136-88BB-FD32-E449-E446663BBE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7CDD2C0-C90F-C37F-92BA-687E6FFCFAF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7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CDA2246-C00B-4C5A-9A2C-9CDCB25C8912}" type="datetimeFigureOut">
              <a:rPr kumimoji="1" lang="ja-JP" altLang="en-US" smtClean="0"/>
              <a:pPr/>
              <a:t>2025/6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45C42D4-0C30-309A-17EA-0E93C9F992D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46A8B1C-BF35-BC5E-6F21-DA4E0C4EEA9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F8B6BA3-1420-4C02-9F04-ECB96141A80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44567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kumimoji="1"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kumimoji="1"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8.png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C06B72BD-F9B9-3C8A-B43E-8DEDCFA3CD0F}"/>
              </a:ext>
            </a:extLst>
          </p:cNvPr>
          <p:cNvSpPr txBox="1"/>
          <p:nvPr/>
        </p:nvSpPr>
        <p:spPr>
          <a:xfrm>
            <a:off x="85003" y="22873"/>
            <a:ext cx="12730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ure 4</a:t>
            </a: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D09E0A56-A5CF-6873-6816-12B11B8A3CC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58049" y="392205"/>
            <a:ext cx="5106473" cy="2337089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E8CE169-CAE0-D983-5A8F-37FF3D30739D}"/>
              </a:ext>
            </a:extLst>
          </p:cNvPr>
          <p:cNvSpPr txBox="1"/>
          <p:nvPr/>
        </p:nvSpPr>
        <p:spPr>
          <a:xfrm>
            <a:off x="393478" y="1359048"/>
            <a:ext cx="11590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MIPEP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ED01D302-6DB8-36D6-B976-170A4EC8519B}"/>
              </a:ext>
            </a:extLst>
          </p:cNvPr>
          <p:cNvSpPr/>
          <p:nvPr/>
        </p:nvSpPr>
        <p:spPr>
          <a:xfrm>
            <a:off x="3296992" y="1359048"/>
            <a:ext cx="1171977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B8498657-7096-3C99-CA50-0E16AAA1B465}"/>
              </a:ext>
            </a:extLst>
          </p:cNvPr>
          <p:cNvSpPr txBox="1"/>
          <p:nvPr/>
        </p:nvSpPr>
        <p:spPr>
          <a:xfrm>
            <a:off x="379256" y="523330"/>
            <a:ext cx="3877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8232952B-C1A3-71D6-B5AA-14A2DFC9FF9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22843" y="2816959"/>
            <a:ext cx="4690113" cy="1368676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F11B12E-FA1B-9C76-6E1F-C2F93BA5B1EE}"/>
              </a:ext>
            </a:extLst>
          </p:cNvPr>
          <p:cNvSpPr txBox="1"/>
          <p:nvPr/>
        </p:nvSpPr>
        <p:spPr>
          <a:xfrm>
            <a:off x="463744" y="3316631"/>
            <a:ext cx="11590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LaminB1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B4B46D69-BE0B-C0C2-56F1-965A7F8A593E}"/>
              </a:ext>
            </a:extLst>
          </p:cNvPr>
          <p:cNvSpPr/>
          <p:nvPr/>
        </p:nvSpPr>
        <p:spPr>
          <a:xfrm>
            <a:off x="3296992" y="3131965"/>
            <a:ext cx="1218563" cy="55399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19" name="図 18">
            <a:extLst>
              <a:ext uri="{FF2B5EF4-FFF2-40B4-BE49-F238E27FC236}">
                <a16:creationId xmlns:a16="http://schemas.microsoft.com/office/drawing/2014/main" id="{AE774565-53D5-4D49-B940-69EA892D06E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78225" y="5535699"/>
            <a:ext cx="5764112" cy="3216125"/>
          </a:xfrm>
          <a:prstGeom prst="rect">
            <a:avLst/>
          </a:prstGeom>
        </p:spPr>
      </p:pic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4B612BAB-4C0D-0423-C987-C11C4B0DEBEE}"/>
              </a:ext>
            </a:extLst>
          </p:cNvPr>
          <p:cNvSpPr/>
          <p:nvPr/>
        </p:nvSpPr>
        <p:spPr>
          <a:xfrm>
            <a:off x="1344986" y="5749066"/>
            <a:ext cx="1872776" cy="9813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B52DC578-8E85-669E-5C2A-D4B7A3EE0771}"/>
              </a:ext>
            </a:extLst>
          </p:cNvPr>
          <p:cNvSpPr txBox="1"/>
          <p:nvPr/>
        </p:nvSpPr>
        <p:spPr>
          <a:xfrm>
            <a:off x="1957691" y="4797035"/>
            <a:ext cx="19572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MIPEP, LaminB1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直線矢印コネクタ 22">
            <a:extLst>
              <a:ext uri="{FF2B5EF4-FFF2-40B4-BE49-F238E27FC236}">
                <a16:creationId xmlns:a16="http://schemas.microsoft.com/office/drawing/2014/main" id="{21851D3A-F161-BBAC-F223-F88F0DE2BFF2}"/>
              </a:ext>
            </a:extLst>
          </p:cNvPr>
          <p:cNvCxnSpPr>
            <a:cxnSpLocks/>
          </p:cNvCxnSpPr>
          <p:nvPr/>
        </p:nvCxnSpPr>
        <p:spPr>
          <a:xfrm flipH="1">
            <a:off x="2069801" y="5166367"/>
            <a:ext cx="660502" cy="51736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" name="テキスト ボックス 20">
            <a:extLst>
              <a:ext uri="{FF2B5EF4-FFF2-40B4-BE49-F238E27FC236}">
                <a16:creationId xmlns:a16="http://schemas.microsoft.com/office/drawing/2014/main" id="{39F938B6-B3DD-4CCE-3092-C1A07F0E0C6C}"/>
              </a:ext>
            </a:extLst>
          </p:cNvPr>
          <p:cNvSpPr txBox="1"/>
          <p:nvPr/>
        </p:nvSpPr>
        <p:spPr>
          <a:xfrm>
            <a:off x="20420" y="5572365"/>
            <a:ext cx="11053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20">
            <a:extLst>
              <a:ext uri="{FF2B5EF4-FFF2-40B4-BE49-F238E27FC236}">
                <a16:creationId xmlns:a16="http://schemas.microsoft.com/office/drawing/2014/main" id="{8A17FB0E-C39F-1CF8-ED09-C5489BD09BDD}"/>
              </a:ext>
            </a:extLst>
          </p:cNvPr>
          <p:cNvSpPr txBox="1"/>
          <p:nvPr/>
        </p:nvSpPr>
        <p:spPr>
          <a:xfrm>
            <a:off x="8866" y="5888156"/>
            <a:ext cx="11053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20">
            <a:extLst>
              <a:ext uri="{FF2B5EF4-FFF2-40B4-BE49-F238E27FC236}">
                <a16:creationId xmlns:a16="http://schemas.microsoft.com/office/drawing/2014/main" id="{D016F8B3-F3C8-829C-706C-F82833C9595A}"/>
              </a:ext>
            </a:extLst>
          </p:cNvPr>
          <p:cNvSpPr txBox="1"/>
          <p:nvPr/>
        </p:nvSpPr>
        <p:spPr>
          <a:xfrm>
            <a:off x="0" y="6408083"/>
            <a:ext cx="11053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20">
            <a:extLst>
              <a:ext uri="{FF2B5EF4-FFF2-40B4-BE49-F238E27FC236}">
                <a16:creationId xmlns:a16="http://schemas.microsoft.com/office/drawing/2014/main" id="{735436BB-6300-CA49-C69E-B72FF4962132}"/>
              </a:ext>
            </a:extLst>
          </p:cNvPr>
          <p:cNvSpPr txBox="1"/>
          <p:nvPr/>
        </p:nvSpPr>
        <p:spPr>
          <a:xfrm>
            <a:off x="8866" y="6814081"/>
            <a:ext cx="11053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20">
            <a:extLst>
              <a:ext uri="{FF2B5EF4-FFF2-40B4-BE49-F238E27FC236}">
                <a16:creationId xmlns:a16="http://schemas.microsoft.com/office/drawing/2014/main" id="{9429E886-63E5-C44D-25F9-D8BC040F2AE0}"/>
              </a:ext>
            </a:extLst>
          </p:cNvPr>
          <p:cNvSpPr txBox="1"/>
          <p:nvPr/>
        </p:nvSpPr>
        <p:spPr>
          <a:xfrm>
            <a:off x="0" y="7413620"/>
            <a:ext cx="11053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20">
            <a:extLst>
              <a:ext uri="{FF2B5EF4-FFF2-40B4-BE49-F238E27FC236}">
                <a16:creationId xmlns:a16="http://schemas.microsoft.com/office/drawing/2014/main" id="{F3AF97E1-262F-7181-E4B7-5CE0025FC75B}"/>
              </a:ext>
            </a:extLst>
          </p:cNvPr>
          <p:cNvSpPr txBox="1"/>
          <p:nvPr/>
        </p:nvSpPr>
        <p:spPr>
          <a:xfrm>
            <a:off x="0" y="7713390"/>
            <a:ext cx="11053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20">
            <a:extLst>
              <a:ext uri="{FF2B5EF4-FFF2-40B4-BE49-F238E27FC236}">
                <a16:creationId xmlns:a16="http://schemas.microsoft.com/office/drawing/2014/main" id="{DB3CC37A-7FD5-E86C-FE6B-CA15FF5C1DB7}"/>
              </a:ext>
            </a:extLst>
          </p:cNvPr>
          <p:cNvSpPr txBox="1"/>
          <p:nvPr/>
        </p:nvSpPr>
        <p:spPr>
          <a:xfrm>
            <a:off x="0" y="8049825"/>
            <a:ext cx="11053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20">
            <a:extLst>
              <a:ext uri="{FF2B5EF4-FFF2-40B4-BE49-F238E27FC236}">
                <a16:creationId xmlns:a16="http://schemas.microsoft.com/office/drawing/2014/main" id="{503757DC-45E2-7888-2CD1-89F93B858CB3}"/>
              </a:ext>
            </a:extLst>
          </p:cNvPr>
          <p:cNvSpPr txBox="1"/>
          <p:nvPr/>
        </p:nvSpPr>
        <p:spPr>
          <a:xfrm>
            <a:off x="-61" y="8457790"/>
            <a:ext cx="11053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030180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1E1C09E-5324-18D6-EFDE-96A2E7EEB99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2EE426EC-4632-8F49-AC2C-DA649FC34A44}"/>
              </a:ext>
            </a:extLst>
          </p:cNvPr>
          <p:cNvSpPr txBox="1"/>
          <p:nvPr/>
        </p:nvSpPr>
        <p:spPr>
          <a:xfrm>
            <a:off x="85003" y="22873"/>
            <a:ext cx="12730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ure 4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E125C201-A4AF-6781-7D22-E4715C8E6C82}"/>
              </a:ext>
            </a:extLst>
          </p:cNvPr>
          <p:cNvSpPr txBox="1"/>
          <p:nvPr/>
        </p:nvSpPr>
        <p:spPr>
          <a:xfrm>
            <a:off x="463744" y="411829"/>
            <a:ext cx="3877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D1959BC3-06C6-D82C-706E-51C3F211E28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1324" y="1188683"/>
            <a:ext cx="6726676" cy="1049183"/>
          </a:xfrm>
          <a:prstGeom prst="rect">
            <a:avLst/>
          </a:prstGeom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AF3A2EF3-73A9-85AB-A612-79FF47287A0C}"/>
              </a:ext>
            </a:extLst>
          </p:cNvPr>
          <p:cNvSpPr txBox="1"/>
          <p:nvPr/>
        </p:nvSpPr>
        <p:spPr>
          <a:xfrm>
            <a:off x="463744" y="819351"/>
            <a:ext cx="3065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ull length MIPEP</a:t>
            </a:r>
            <a:r>
              <a:rPr kumimoji="1" lang="ja-JP" altLang="en-US">
                <a:latin typeface="Arial" panose="020B0604020202020204" pitchFamily="34" charset="0"/>
                <a:cs typeface="Arial" panose="020B0604020202020204" pitchFamily="34" charset="0"/>
              </a:rPr>
              <a:t>、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ΔMIPEP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BEEACD27-7C33-B2A0-ECA2-A32AA2384C14}"/>
              </a:ext>
            </a:extLst>
          </p:cNvPr>
          <p:cNvSpPr/>
          <p:nvPr/>
        </p:nvSpPr>
        <p:spPr>
          <a:xfrm>
            <a:off x="3529412" y="1470299"/>
            <a:ext cx="2491099" cy="35678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DF85F325-42C3-7D62-94E3-4DFDBFE83257}"/>
              </a:ext>
            </a:extLst>
          </p:cNvPr>
          <p:cNvSpPr txBox="1"/>
          <p:nvPr/>
        </p:nvSpPr>
        <p:spPr>
          <a:xfrm>
            <a:off x="657599" y="2592018"/>
            <a:ext cx="11590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LaminB1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図 16">
            <a:extLst>
              <a:ext uri="{FF2B5EF4-FFF2-40B4-BE49-F238E27FC236}">
                <a16:creationId xmlns:a16="http://schemas.microsoft.com/office/drawing/2014/main" id="{88EB78A2-9F53-7913-1260-687C5B7A3F5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9256" y="2897651"/>
            <a:ext cx="6478744" cy="1166695"/>
          </a:xfrm>
          <a:prstGeom prst="rect">
            <a:avLst/>
          </a:prstGeom>
        </p:spPr>
      </p:pic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0BF7AC88-A943-C0FA-EF0A-9880497A7A51}"/>
              </a:ext>
            </a:extLst>
          </p:cNvPr>
          <p:cNvSpPr/>
          <p:nvPr/>
        </p:nvSpPr>
        <p:spPr>
          <a:xfrm>
            <a:off x="3601372" y="3268770"/>
            <a:ext cx="2491099" cy="35678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13" name="図 12">
            <a:extLst>
              <a:ext uri="{FF2B5EF4-FFF2-40B4-BE49-F238E27FC236}">
                <a16:creationId xmlns:a16="http://schemas.microsoft.com/office/drawing/2014/main" id="{28BF0265-D6F6-F38A-3265-5E76E9A8E04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11791" y="4748863"/>
            <a:ext cx="5632411" cy="4130435"/>
          </a:xfrm>
          <a:prstGeom prst="rect">
            <a:avLst/>
          </a:prstGeom>
        </p:spPr>
      </p:pic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20FF9BC8-7D9C-4FDB-0304-EE9177F334D2}"/>
              </a:ext>
            </a:extLst>
          </p:cNvPr>
          <p:cNvSpPr/>
          <p:nvPr/>
        </p:nvSpPr>
        <p:spPr>
          <a:xfrm>
            <a:off x="3827996" y="5663226"/>
            <a:ext cx="2018213" cy="92277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7DD86918-1BF1-CA75-E52B-51BCF41BB5D7}"/>
              </a:ext>
            </a:extLst>
          </p:cNvPr>
          <p:cNvSpPr txBox="1"/>
          <p:nvPr/>
        </p:nvSpPr>
        <p:spPr>
          <a:xfrm>
            <a:off x="3601372" y="4356786"/>
            <a:ext cx="19572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MIPEP, LaminB1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直線矢印コネクタ 19">
            <a:extLst>
              <a:ext uri="{FF2B5EF4-FFF2-40B4-BE49-F238E27FC236}">
                <a16:creationId xmlns:a16="http://schemas.microsoft.com/office/drawing/2014/main" id="{79F05D99-E0DD-1231-3D4F-F6B9E3DA84B9}"/>
              </a:ext>
            </a:extLst>
          </p:cNvPr>
          <p:cNvCxnSpPr>
            <a:cxnSpLocks/>
          </p:cNvCxnSpPr>
          <p:nvPr/>
        </p:nvCxnSpPr>
        <p:spPr>
          <a:xfrm>
            <a:off x="4373984" y="4726118"/>
            <a:ext cx="0" cy="84624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" name="テキスト ボックス 20">
            <a:extLst>
              <a:ext uri="{FF2B5EF4-FFF2-40B4-BE49-F238E27FC236}">
                <a16:creationId xmlns:a16="http://schemas.microsoft.com/office/drawing/2014/main" id="{2DAE950B-B9F6-BD2B-99D0-59D190023AC1}"/>
              </a:ext>
            </a:extLst>
          </p:cNvPr>
          <p:cNvSpPr txBox="1"/>
          <p:nvPr/>
        </p:nvSpPr>
        <p:spPr>
          <a:xfrm>
            <a:off x="20420" y="5572365"/>
            <a:ext cx="11053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20">
            <a:extLst>
              <a:ext uri="{FF2B5EF4-FFF2-40B4-BE49-F238E27FC236}">
                <a16:creationId xmlns:a16="http://schemas.microsoft.com/office/drawing/2014/main" id="{29D286E8-82E1-61DC-F05C-8BBF4949A83C}"/>
              </a:ext>
            </a:extLst>
          </p:cNvPr>
          <p:cNvSpPr txBox="1"/>
          <p:nvPr/>
        </p:nvSpPr>
        <p:spPr>
          <a:xfrm>
            <a:off x="8866" y="5888156"/>
            <a:ext cx="11053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20">
            <a:extLst>
              <a:ext uri="{FF2B5EF4-FFF2-40B4-BE49-F238E27FC236}">
                <a16:creationId xmlns:a16="http://schemas.microsoft.com/office/drawing/2014/main" id="{6F99DE46-CE98-52C9-4455-166E021AF357}"/>
              </a:ext>
            </a:extLst>
          </p:cNvPr>
          <p:cNvSpPr txBox="1"/>
          <p:nvPr/>
        </p:nvSpPr>
        <p:spPr>
          <a:xfrm>
            <a:off x="0" y="6408083"/>
            <a:ext cx="11053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20">
            <a:extLst>
              <a:ext uri="{FF2B5EF4-FFF2-40B4-BE49-F238E27FC236}">
                <a16:creationId xmlns:a16="http://schemas.microsoft.com/office/drawing/2014/main" id="{97E9C752-2DFB-D7B1-2818-E9C8569C4CB5}"/>
              </a:ext>
            </a:extLst>
          </p:cNvPr>
          <p:cNvSpPr txBox="1"/>
          <p:nvPr/>
        </p:nvSpPr>
        <p:spPr>
          <a:xfrm>
            <a:off x="8866" y="6814081"/>
            <a:ext cx="11053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20">
            <a:extLst>
              <a:ext uri="{FF2B5EF4-FFF2-40B4-BE49-F238E27FC236}">
                <a16:creationId xmlns:a16="http://schemas.microsoft.com/office/drawing/2014/main" id="{C1C092D5-4D33-BA93-553B-0B3FEBA6E0CB}"/>
              </a:ext>
            </a:extLst>
          </p:cNvPr>
          <p:cNvSpPr txBox="1"/>
          <p:nvPr/>
        </p:nvSpPr>
        <p:spPr>
          <a:xfrm>
            <a:off x="0" y="7413620"/>
            <a:ext cx="11053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20">
            <a:extLst>
              <a:ext uri="{FF2B5EF4-FFF2-40B4-BE49-F238E27FC236}">
                <a16:creationId xmlns:a16="http://schemas.microsoft.com/office/drawing/2014/main" id="{E0DA4C6C-E9CC-4B28-2017-1661F0691F16}"/>
              </a:ext>
            </a:extLst>
          </p:cNvPr>
          <p:cNvSpPr txBox="1"/>
          <p:nvPr/>
        </p:nvSpPr>
        <p:spPr>
          <a:xfrm>
            <a:off x="0" y="7713390"/>
            <a:ext cx="11053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20">
            <a:extLst>
              <a:ext uri="{FF2B5EF4-FFF2-40B4-BE49-F238E27FC236}">
                <a16:creationId xmlns:a16="http://schemas.microsoft.com/office/drawing/2014/main" id="{BEB121E8-28FA-FC9D-6820-D709580CE652}"/>
              </a:ext>
            </a:extLst>
          </p:cNvPr>
          <p:cNvSpPr txBox="1"/>
          <p:nvPr/>
        </p:nvSpPr>
        <p:spPr>
          <a:xfrm>
            <a:off x="0" y="8049825"/>
            <a:ext cx="11053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38A36866-09A6-FBE0-6C74-A87505AC8CB3}"/>
              </a:ext>
            </a:extLst>
          </p:cNvPr>
          <p:cNvSpPr txBox="1"/>
          <p:nvPr/>
        </p:nvSpPr>
        <p:spPr>
          <a:xfrm>
            <a:off x="-61" y="8457790"/>
            <a:ext cx="11053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851059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1B63F99-FCFD-1378-CB07-82E1D327C2F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D7582501-ED29-2EF3-F420-934589C5CD7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57000" y="748719"/>
            <a:ext cx="4699730" cy="1856286"/>
          </a:xfrm>
          <a:prstGeom prst="rect">
            <a:avLst/>
          </a:prstGeom>
        </p:spPr>
      </p:pic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C0B18DA0-93CD-91FA-9F71-79EFF0F5A6F1}"/>
              </a:ext>
            </a:extLst>
          </p:cNvPr>
          <p:cNvSpPr txBox="1"/>
          <p:nvPr/>
        </p:nvSpPr>
        <p:spPr>
          <a:xfrm>
            <a:off x="85003" y="22873"/>
            <a:ext cx="12730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ure 4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D928D81-1ACD-4F83-8951-C0A371B79551}"/>
              </a:ext>
            </a:extLst>
          </p:cNvPr>
          <p:cNvSpPr txBox="1"/>
          <p:nvPr/>
        </p:nvSpPr>
        <p:spPr>
          <a:xfrm>
            <a:off x="573111" y="1525598"/>
            <a:ext cx="11590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IRT3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19653361-F0EE-BF3B-4167-CB5171D3A26D}"/>
              </a:ext>
            </a:extLst>
          </p:cNvPr>
          <p:cNvSpPr txBox="1"/>
          <p:nvPr/>
        </p:nvSpPr>
        <p:spPr>
          <a:xfrm>
            <a:off x="379256" y="523330"/>
            <a:ext cx="3877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70CB568B-D7BB-7D95-8F73-020D2272622D}"/>
              </a:ext>
            </a:extLst>
          </p:cNvPr>
          <p:cNvSpPr txBox="1"/>
          <p:nvPr/>
        </p:nvSpPr>
        <p:spPr>
          <a:xfrm>
            <a:off x="571645" y="5545427"/>
            <a:ext cx="11590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OX4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CC06ABFC-6D80-9F6A-622C-000C4D3A1F1D}"/>
              </a:ext>
            </a:extLst>
          </p:cNvPr>
          <p:cNvSpPr/>
          <p:nvPr/>
        </p:nvSpPr>
        <p:spPr>
          <a:xfrm>
            <a:off x="2843011" y="1894930"/>
            <a:ext cx="3205092" cy="45638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1439D28B-DD1E-BA5C-00BA-D572079584EF}"/>
              </a:ext>
            </a:extLst>
          </p:cNvPr>
          <p:cNvSpPr txBox="1"/>
          <p:nvPr/>
        </p:nvSpPr>
        <p:spPr>
          <a:xfrm>
            <a:off x="571645" y="3525558"/>
            <a:ext cx="11590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MDH2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ED376477-47F5-04DA-F08A-FA2DEE0E9133}"/>
              </a:ext>
            </a:extLst>
          </p:cNvPr>
          <p:cNvSpPr txBox="1"/>
          <p:nvPr/>
        </p:nvSpPr>
        <p:spPr>
          <a:xfrm>
            <a:off x="571645" y="7234153"/>
            <a:ext cx="11590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LaminB1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図 19">
            <a:extLst>
              <a:ext uri="{FF2B5EF4-FFF2-40B4-BE49-F238E27FC236}">
                <a16:creationId xmlns:a16="http://schemas.microsoft.com/office/drawing/2014/main" id="{5DD69724-709B-A4E6-4521-665CE962AEC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49060" y="2733463"/>
            <a:ext cx="4707670" cy="1953523"/>
          </a:xfrm>
          <a:prstGeom prst="rect">
            <a:avLst/>
          </a:prstGeom>
        </p:spPr>
      </p:pic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52A0DBAD-BC90-2628-5F7E-233AF824E5A8}"/>
              </a:ext>
            </a:extLst>
          </p:cNvPr>
          <p:cNvSpPr/>
          <p:nvPr/>
        </p:nvSpPr>
        <p:spPr>
          <a:xfrm>
            <a:off x="2843011" y="3538248"/>
            <a:ext cx="3205092" cy="5504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21" name="図 20">
            <a:extLst>
              <a:ext uri="{FF2B5EF4-FFF2-40B4-BE49-F238E27FC236}">
                <a16:creationId xmlns:a16="http://schemas.microsoft.com/office/drawing/2014/main" id="{D79930AF-4D9B-DA6D-CAE2-0CD86E9ED2B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49060" y="4832262"/>
            <a:ext cx="4699000" cy="1828800"/>
          </a:xfrm>
          <a:prstGeom prst="rect">
            <a:avLst/>
          </a:prstGeom>
        </p:spPr>
      </p:pic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9568B622-D2FA-D948-6D56-9BFCE629A086}"/>
              </a:ext>
            </a:extLst>
          </p:cNvPr>
          <p:cNvSpPr/>
          <p:nvPr/>
        </p:nvSpPr>
        <p:spPr>
          <a:xfrm>
            <a:off x="2778577" y="5352854"/>
            <a:ext cx="3205092" cy="5504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23" name="図 22">
            <a:extLst>
              <a:ext uri="{FF2B5EF4-FFF2-40B4-BE49-F238E27FC236}">
                <a16:creationId xmlns:a16="http://schemas.microsoft.com/office/drawing/2014/main" id="{1C9AD14A-DFC4-37E0-EEB5-681E896F4CD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957000" y="6806338"/>
            <a:ext cx="4700609" cy="1371011"/>
          </a:xfrm>
          <a:prstGeom prst="rect">
            <a:avLst/>
          </a:prstGeom>
        </p:spPr>
      </p:pic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372ECD0F-46A6-23C0-1C0C-1D858AB21598}"/>
              </a:ext>
            </a:extLst>
          </p:cNvPr>
          <p:cNvSpPr/>
          <p:nvPr/>
        </p:nvSpPr>
        <p:spPr>
          <a:xfrm>
            <a:off x="2843011" y="7182107"/>
            <a:ext cx="3205092" cy="5504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79571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3833B6B-BFED-E1AE-D38A-C30CA3CD261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Picture 18">
            <a:extLst>
              <a:ext uri="{FF2B5EF4-FFF2-40B4-BE49-F238E27FC236}">
                <a16:creationId xmlns:a16="http://schemas.microsoft.com/office/drawing/2014/main" id="{497B4B6A-EBCC-50E6-62CB-F9E5C31F771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16406" y="1587044"/>
            <a:ext cx="4815839" cy="3202767"/>
          </a:xfrm>
          <a:prstGeom prst="rect">
            <a:avLst/>
          </a:prstGeom>
        </p:spPr>
      </p:pic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D0DCDB98-BC39-8659-C50E-936F06AB099C}"/>
              </a:ext>
            </a:extLst>
          </p:cNvPr>
          <p:cNvSpPr txBox="1"/>
          <p:nvPr/>
        </p:nvSpPr>
        <p:spPr>
          <a:xfrm>
            <a:off x="85003" y="22873"/>
            <a:ext cx="12730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ure 4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BFC69052-C346-BD91-AD6F-690FEF3E07F5}"/>
              </a:ext>
            </a:extLst>
          </p:cNvPr>
          <p:cNvSpPr txBox="1"/>
          <p:nvPr/>
        </p:nvSpPr>
        <p:spPr>
          <a:xfrm>
            <a:off x="476536" y="523330"/>
            <a:ext cx="3877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A8C4D422-C4C5-22F0-2B6C-E12A91F4F0FE}"/>
              </a:ext>
            </a:extLst>
          </p:cNvPr>
          <p:cNvSpPr/>
          <p:nvPr/>
        </p:nvSpPr>
        <p:spPr>
          <a:xfrm>
            <a:off x="3813414" y="2179538"/>
            <a:ext cx="1595744" cy="65103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4C96D4CE-A242-1F83-92A6-CEAED851FF40}"/>
              </a:ext>
            </a:extLst>
          </p:cNvPr>
          <p:cNvSpPr/>
          <p:nvPr/>
        </p:nvSpPr>
        <p:spPr>
          <a:xfrm>
            <a:off x="3813415" y="2829298"/>
            <a:ext cx="1595744" cy="79623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E678CB11-54BE-86F8-078F-F8BD611D07A9}"/>
              </a:ext>
            </a:extLst>
          </p:cNvPr>
          <p:cNvCxnSpPr>
            <a:cxnSpLocks/>
          </p:cNvCxnSpPr>
          <p:nvPr/>
        </p:nvCxnSpPr>
        <p:spPr>
          <a:xfrm>
            <a:off x="3548460" y="2179538"/>
            <a:ext cx="3057610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CD7D888F-EA7A-76D9-6F35-717AA1AD688C}"/>
              </a:ext>
            </a:extLst>
          </p:cNvPr>
          <p:cNvCxnSpPr>
            <a:cxnSpLocks/>
          </p:cNvCxnSpPr>
          <p:nvPr/>
        </p:nvCxnSpPr>
        <p:spPr>
          <a:xfrm>
            <a:off x="3548460" y="2827447"/>
            <a:ext cx="3057610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3DD3D569-6905-57A8-939D-C6DB7A3C558F}"/>
              </a:ext>
            </a:extLst>
          </p:cNvPr>
          <p:cNvSpPr txBox="1"/>
          <p:nvPr/>
        </p:nvSpPr>
        <p:spPr>
          <a:xfrm>
            <a:off x="5820246" y="2318630"/>
            <a:ext cx="10928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LaminB1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7F59971B-2313-ADB5-F10A-48FB8D30510F}"/>
              </a:ext>
            </a:extLst>
          </p:cNvPr>
          <p:cNvSpPr txBox="1"/>
          <p:nvPr/>
        </p:nvSpPr>
        <p:spPr>
          <a:xfrm>
            <a:off x="5933860" y="2960672"/>
            <a:ext cx="10928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IRT3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DH2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9A9FE381-17A3-9097-9644-0E82D08258B6}"/>
              </a:ext>
            </a:extLst>
          </p:cNvPr>
          <p:cNvSpPr txBox="1"/>
          <p:nvPr/>
        </p:nvSpPr>
        <p:spPr>
          <a:xfrm>
            <a:off x="5940983" y="3984102"/>
            <a:ext cx="10928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OX4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id="{0BA11D98-3BE8-7234-83B5-44374D45A33F}"/>
              </a:ext>
            </a:extLst>
          </p:cNvPr>
          <p:cNvSpPr/>
          <p:nvPr/>
        </p:nvSpPr>
        <p:spPr>
          <a:xfrm>
            <a:off x="3813415" y="3790092"/>
            <a:ext cx="1595744" cy="75693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CC5FAF48-DF1A-7928-E233-31864464DC06}"/>
              </a:ext>
            </a:extLst>
          </p:cNvPr>
          <p:cNvCxnSpPr>
            <a:cxnSpLocks/>
          </p:cNvCxnSpPr>
          <p:nvPr/>
        </p:nvCxnSpPr>
        <p:spPr>
          <a:xfrm>
            <a:off x="3531889" y="3625532"/>
            <a:ext cx="3074181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2FA79CC9-1823-A48B-7299-9FD88CAF30DE}"/>
              </a:ext>
            </a:extLst>
          </p:cNvPr>
          <p:cNvCxnSpPr>
            <a:cxnSpLocks/>
          </p:cNvCxnSpPr>
          <p:nvPr/>
        </p:nvCxnSpPr>
        <p:spPr>
          <a:xfrm>
            <a:off x="3531889" y="4547029"/>
            <a:ext cx="3074181" cy="1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" name="テキスト ボックス 20">
            <a:extLst>
              <a:ext uri="{FF2B5EF4-FFF2-40B4-BE49-F238E27FC236}">
                <a16:creationId xmlns:a16="http://schemas.microsoft.com/office/drawing/2014/main" id="{9B5E62A0-12A4-E684-07A5-E01BCDD44DF7}"/>
              </a:ext>
            </a:extLst>
          </p:cNvPr>
          <p:cNvSpPr txBox="1"/>
          <p:nvPr/>
        </p:nvSpPr>
        <p:spPr>
          <a:xfrm>
            <a:off x="151112" y="1983731"/>
            <a:ext cx="11053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20">
            <a:extLst>
              <a:ext uri="{FF2B5EF4-FFF2-40B4-BE49-F238E27FC236}">
                <a16:creationId xmlns:a16="http://schemas.microsoft.com/office/drawing/2014/main" id="{E9B4279F-F551-D6AC-40AC-293C8E50ECAC}"/>
              </a:ext>
            </a:extLst>
          </p:cNvPr>
          <p:cNvSpPr txBox="1"/>
          <p:nvPr/>
        </p:nvSpPr>
        <p:spPr>
          <a:xfrm>
            <a:off x="182422" y="2200602"/>
            <a:ext cx="11053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20">
            <a:extLst>
              <a:ext uri="{FF2B5EF4-FFF2-40B4-BE49-F238E27FC236}">
                <a16:creationId xmlns:a16="http://schemas.microsoft.com/office/drawing/2014/main" id="{A51A8F6E-6FBC-644B-4F33-EAB7769ED26F}"/>
              </a:ext>
            </a:extLst>
          </p:cNvPr>
          <p:cNvSpPr txBox="1"/>
          <p:nvPr/>
        </p:nvSpPr>
        <p:spPr>
          <a:xfrm>
            <a:off x="173556" y="2657825"/>
            <a:ext cx="11053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20">
            <a:extLst>
              <a:ext uri="{FF2B5EF4-FFF2-40B4-BE49-F238E27FC236}">
                <a16:creationId xmlns:a16="http://schemas.microsoft.com/office/drawing/2014/main" id="{33CCDF3D-0359-17A0-E01A-C7EF36AED880}"/>
              </a:ext>
            </a:extLst>
          </p:cNvPr>
          <p:cNvSpPr txBox="1"/>
          <p:nvPr/>
        </p:nvSpPr>
        <p:spPr>
          <a:xfrm>
            <a:off x="182422" y="2985448"/>
            <a:ext cx="11053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20">
            <a:extLst>
              <a:ext uri="{FF2B5EF4-FFF2-40B4-BE49-F238E27FC236}">
                <a16:creationId xmlns:a16="http://schemas.microsoft.com/office/drawing/2014/main" id="{A5589DEA-C0FC-C617-D2BD-A204C2362822}"/>
              </a:ext>
            </a:extLst>
          </p:cNvPr>
          <p:cNvSpPr txBox="1"/>
          <p:nvPr/>
        </p:nvSpPr>
        <p:spPr>
          <a:xfrm>
            <a:off x="173556" y="3588471"/>
            <a:ext cx="11053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20">
            <a:extLst>
              <a:ext uri="{FF2B5EF4-FFF2-40B4-BE49-F238E27FC236}">
                <a16:creationId xmlns:a16="http://schemas.microsoft.com/office/drawing/2014/main" id="{997D8A8D-AE81-3DEA-C001-6DE02D7ECF27}"/>
              </a:ext>
            </a:extLst>
          </p:cNvPr>
          <p:cNvSpPr txBox="1"/>
          <p:nvPr/>
        </p:nvSpPr>
        <p:spPr>
          <a:xfrm>
            <a:off x="173556" y="3783736"/>
            <a:ext cx="11053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20">
            <a:extLst>
              <a:ext uri="{FF2B5EF4-FFF2-40B4-BE49-F238E27FC236}">
                <a16:creationId xmlns:a16="http://schemas.microsoft.com/office/drawing/2014/main" id="{87CC041B-DBA5-C8AE-EDA6-C5334D3E424B}"/>
              </a:ext>
            </a:extLst>
          </p:cNvPr>
          <p:cNvSpPr txBox="1"/>
          <p:nvPr/>
        </p:nvSpPr>
        <p:spPr>
          <a:xfrm>
            <a:off x="173556" y="4076626"/>
            <a:ext cx="11053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20">
            <a:extLst>
              <a:ext uri="{FF2B5EF4-FFF2-40B4-BE49-F238E27FC236}">
                <a16:creationId xmlns:a16="http://schemas.microsoft.com/office/drawing/2014/main" id="{4EE52F05-D4E3-B64F-1DBA-15F7DB2FD5CA}"/>
              </a:ext>
            </a:extLst>
          </p:cNvPr>
          <p:cNvSpPr txBox="1"/>
          <p:nvPr/>
        </p:nvSpPr>
        <p:spPr>
          <a:xfrm>
            <a:off x="173495" y="4484591"/>
            <a:ext cx="11053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直線コネクタ 16">
            <a:extLst>
              <a:ext uri="{FF2B5EF4-FFF2-40B4-BE49-F238E27FC236}">
                <a16:creationId xmlns:a16="http://schemas.microsoft.com/office/drawing/2014/main" id="{8067D9EC-0835-C0FF-BA5A-4E8D756F8CC4}"/>
              </a:ext>
            </a:extLst>
          </p:cNvPr>
          <p:cNvCxnSpPr>
            <a:cxnSpLocks/>
          </p:cNvCxnSpPr>
          <p:nvPr/>
        </p:nvCxnSpPr>
        <p:spPr>
          <a:xfrm>
            <a:off x="3531889" y="3774521"/>
            <a:ext cx="3074181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4345497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2024CF6-FCB7-3B23-612B-86852F86CE6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0" name="テキスト ボックス 149">
            <a:extLst>
              <a:ext uri="{FF2B5EF4-FFF2-40B4-BE49-F238E27FC236}">
                <a16:creationId xmlns:a16="http://schemas.microsoft.com/office/drawing/2014/main" id="{71202D4C-F20E-FC65-BEA0-54C822CEF48E}"/>
              </a:ext>
            </a:extLst>
          </p:cNvPr>
          <p:cNvSpPr txBox="1"/>
          <p:nvPr/>
        </p:nvSpPr>
        <p:spPr>
          <a:xfrm>
            <a:off x="28160" y="14717"/>
            <a:ext cx="61327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2A137E8-9E76-C7C8-034D-70E5F2226779}"/>
              </a:ext>
            </a:extLst>
          </p:cNvPr>
          <p:cNvSpPr txBox="1"/>
          <p:nvPr/>
        </p:nvSpPr>
        <p:spPr>
          <a:xfrm>
            <a:off x="379256" y="523330"/>
            <a:ext cx="3877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7EB3E810-AD06-F3D0-81E1-34327EC3C7A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119495"/>
            <a:ext cx="6858000" cy="1132910"/>
          </a:xfrm>
          <a:prstGeom prst="rect">
            <a:avLst/>
          </a:prstGeom>
        </p:spPr>
      </p:pic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9A3098E4-836F-BE0B-6514-B1ED0BFFA7DF}"/>
              </a:ext>
            </a:extLst>
          </p:cNvPr>
          <p:cNvSpPr/>
          <p:nvPr/>
        </p:nvSpPr>
        <p:spPr>
          <a:xfrm>
            <a:off x="455472" y="1469172"/>
            <a:ext cx="2491099" cy="35678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1A77643-533F-24DE-4220-BD218C30EDA3}"/>
              </a:ext>
            </a:extLst>
          </p:cNvPr>
          <p:cNvSpPr txBox="1"/>
          <p:nvPr/>
        </p:nvSpPr>
        <p:spPr>
          <a:xfrm>
            <a:off x="463744" y="819351"/>
            <a:ext cx="3065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ull length MIPEP</a:t>
            </a:r>
            <a:r>
              <a:rPr kumimoji="1" lang="ja-JP" altLang="en-US">
                <a:latin typeface="Arial" panose="020B0604020202020204" pitchFamily="34" charset="0"/>
                <a:cs typeface="Arial" panose="020B0604020202020204" pitchFamily="34" charset="0"/>
              </a:rPr>
              <a:t>、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ΔMIPEP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93397DE1-E0AC-197A-3D73-77E51F731321}"/>
              </a:ext>
            </a:extLst>
          </p:cNvPr>
          <p:cNvSpPr txBox="1"/>
          <p:nvPr/>
        </p:nvSpPr>
        <p:spPr>
          <a:xfrm>
            <a:off x="657599" y="2592018"/>
            <a:ext cx="11590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LaminB1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ADE0D760-1015-E5AD-F73B-99B669AFE2E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2888737"/>
            <a:ext cx="6858000" cy="1229096"/>
          </a:xfrm>
          <a:prstGeom prst="rect">
            <a:avLst/>
          </a:prstGeom>
        </p:spPr>
      </p:pic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168DD8B8-C52E-FBB6-B25D-A6386A3E5B05}"/>
              </a:ext>
            </a:extLst>
          </p:cNvPr>
          <p:cNvSpPr/>
          <p:nvPr/>
        </p:nvSpPr>
        <p:spPr>
          <a:xfrm>
            <a:off x="445743" y="3324892"/>
            <a:ext cx="2550375" cy="36933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10" name="図 9">
            <a:extLst>
              <a:ext uri="{FF2B5EF4-FFF2-40B4-BE49-F238E27FC236}">
                <a16:creationId xmlns:a16="http://schemas.microsoft.com/office/drawing/2014/main" id="{344E55F6-57C6-2A35-8D6F-3E269E5BAC3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99957" y="4712151"/>
            <a:ext cx="5799604" cy="4211930"/>
          </a:xfrm>
          <a:prstGeom prst="rect">
            <a:avLst/>
          </a:prstGeom>
        </p:spPr>
      </p:pic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2FDEF2BF-8C8B-0B02-DC85-657BF1C1EB14}"/>
              </a:ext>
            </a:extLst>
          </p:cNvPr>
          <p:cNvSpPr/>
          <p:nvPr/>
        </p:nvSpPr>
        <p:spPr>
          <a:xfrm>
            <a:off x="1399387" y="5694744"/>
            <a:ext cx="2029613" cy="9606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D4D497DF-EBF4-3A5A-10BB-EF6D5D2B4D31}"/>
              </a:ext>
            </a:extLst>
          </p:cNvPr>
          <p:cNvSpPr txBox="1"/>
          <p:nvPr/>
        </p:nvSpPr>
        <p:spPr>
          <a:xfrm>
            <a:off x="834765" y="4230326"/>
            <a:ext cx="19572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MIPEP, LaminB1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直線矢印コネクタ 12">
            <a:extLst>
              <a:ext uri="{FF2B5EF4-FFF2-40B4-BE49-F238E27FC236}">
                <a16:creationId xmlns:a16="http://schemas.microsoft.com/office/drawing/2014/main" id="{7D749E1F-6232-7ACC-1054-0387E53B4981}"/>
              </a:ext>
            </a:extLst>
          </p:cNvPr>
          <p:cNvCxnSpPr>
            <a:cxnSpLocks/>
          </p:cNvCxnSpPr>
          <p:nvPr/>
        </p:nvCxnSpPr>
        <p:spPr>
          <a:xfrm>
            <a:off x="1607377" y="4599658"/>
            <a:ext cx="0" cy="109508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" name="テキスト ボックス 20">
            <a:extLst>
              <a:ext uri="{FF2B5EF4-FFF2-40B4-BE49-F238E27FC236}">
                <a16:creationId xmlns:a16="http://schemas.microsoft.com/office/drawing/2014/main" id="{FDC39192-C649-8CAA-6450-F509FF698C22}"/>
              </a:ext>
            </a:extLst>
          </p:cNvPr>
          <p:cNvSpPr txBox="1"/>
          <p:nvPr/>
        </p:nvSpPr>
        <p:spPr>
          <a:xfrm>
            <a:off x="-52732" y="5572365"/>
            <a:ext cx="11053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20">
            <a:extLst>
              <a:ext uri="{FF2B5EF4-FFF2-40B4-BE49-F238E27FC236}">
                <a16:creationId xmlns:a16="http://schemas.microsoft.com/office/drawing/2014/main" id="{09099CA0-B6F7-1BD9-AD54-722DD2D2E138}"/>
              </a:ext>
            </a:extLst>
          </p:cNvPr>
          <p:cNvSpPr txBox="1"/>
          <p:nvPr/>
        </p:nvSpPr>
        <p:spPr>
          <a:xfrm>
            <a:off x="8866" y="5888156"/>
            <a:ext cx="11053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20">
            <a:extLst>
              <a:ext uri="{FF2B5EF4-FFF2-40B4-BE49-F238E27FC236}">
                <a16:creationId xmlns:a16="http://schemas.microsoft.com/office/drawing/2014/main" id="{A5649B06-B403-8613-955E-64758B802017}"/>
              </a:ext>
            </a:extLst>
          </p:cNvPr>
          <p:cNvSpPr txBox="1"/>
          <p:nvPr/>
        </p:nvSpPr>
        <p:spPr>
          <a:xfrm>
            <a:off x="0" y="6408083"/>
            <a:ext cx="11053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20">
            <a:extLst>
              <a:ext uri="{FF2B5EF4-FFF2-40B4-BE49-F238E27FC236}">
                <a16:creationId xmlns:a16="http://schemas.microsoft.com/office/drawing/2014/main" id="{420288A7-C7CC-533B-906E-C33B28DAA61C}"/>
              </a:ext>
            </a:extLst>
          </p:cNvPr>
          <p:cNvSpPr txBox="1"/>
          <p:nvPr/>
        </p:nvSpPr>
        <p:spPr>
          <a:xfrm>
            <a:off x="8866" y="6814081"/>
            <a:ext cx="11053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20">
            <a:extLst>
              <a:ext uri="{FF2B5EF4-FFF2-40B4-BE49-F238E27FC236}">
                <a16:creationId xmlns:a16="http://schemas.microsoft.com/office/drawing/2014/main" id="{C707018D-F587-632E-8516-CD25B7459BBA}"/>
              </a:ext>
            </a:extLst>
          </p:cNvPr>
          <p:cNvSpPr txBox="1"/>
          <p:nvPr/>
        </p:nvSpPr>
        <p:spPr>
          <a:xfrm>
            <a:off x="0" y="7413620"/>
            <a:ext cx="11053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20">
            <a:extLst>
              <a:ext uri="{FF2B5EF4-FFF2-40B4-BE49-F238E27FC236}">
                <a16:creationId xmlns:a16="http://schemas.microsoft.com/office/drawing/2014/main" id="{E0288E14-A5DA-6C4A-5DBA-163467CA483F}"/>
              </a:ext>
            </a:extLst>
          </p:cNvPr>
          <p:cNvSpPr txBox="1"/>
          <p:nvPr/>
        </p:nvSpPr>
        <p:spPr>
          <a:xfrm>
            <a:off x="0" y="7713390"/>
            <a:ext cx="11053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20">
            <a:extLst>
              <a:ext uri="{FF2B5EF4-FFF2-40B4-BE49-F238E27FC236}">
                <a16:creationId xmlns:a16="http://schemas.microsoft.com/office/drawing/2014/main" id="{F3124AAC-AD8E-969D-7422-C97BBCF90F32}"/>
              </a:ext>
            </a:extLst>
          </p:cNvPr>
          <p:cNvSpPr txBox="1"/>
          <p:nvPr/>
        </p:nvSpPr>
        <p:spPr>
          <a:xfrm>
            <a:off x="0" y="8049825"/>
            <a:ext cx="11053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20">
            <a:extLst>
              <a:ext uri="{FF2B5EF4-FFF2-40B4-BE49-F238E27FC236}">
                <a16:creationId xmlns:a16="http://schemas.microsoft.com/office/drawing/2014/main" id="{C48540DE-716D-3F24-DA96-E76E1B2D21A4}"/>
              </a:ext>
            </a:extLst>
          </p:cNvPr>
          <p:cNvSpPr txBox="1"/>
          <p:nvPr/>
        </p:nvSpPr>
        <p:spPr>
          <a:xfrm>
            <a:off x="-61" y="8457790"/>
            <a:ext cx="11053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601416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A7FB9C8-6FA4-DBA3-C1D1-6951D161723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>
            <a:extLst>
              <a:ext uri="{FF2B5EF4-FFF2-40B4-BE49-F238E27FC236}">
                <a16:creationId xmlns:a16="http://schemas.microsoft.com/office/drawing/2014/main" id="{FDC8F66B-DA8B-2C52-BE12-A781A62859C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92096" y="757655"/>
            <a:ext cx="4498848" cy="1705377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A7561C34-508B-3625-80A0-C84109C1926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86000" y="2801319"/>
            <a:ext cx="4498848" cy="1716519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AD19CB3C-8EFF-F799-C6D4-AFCDB2ED596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61616" y="7115004"/>
            <a:ext cx="4523232" cy="1400222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9DF27A2A-BCE7-3B70-5087-EB3BB87AD79C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t="2156"/>
          <a:stretch>
            <a:fillRect/>
          </a:stretch>
        </p:blipFill>
        <p:spPr>
          <a:xfrm>
            <a:off x="2286000" y="5017690"/>
            <a:ext cx="4523232" cy="1599273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71CDD7A-7AA7-081E-2A52-F46F807906A3}"/>
              </a:ext>
            </a:extLst>
          </p:cNvPr>
          <p:cNvSpPr txBox="1"/>
          <p:nvPr/>
        </p:nvSpPr>
        <p:spPr>
          <a:xfrm>
            <a:off x="573111" y="1525598"/>
            <a:ext cx="11590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IRT3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E36AB678-DE31-DE83-C92B-EDD8103D6FE3}"/>
              </a:ext>
            </a:extLst>
          </p:cNvPr>
          <p:cNvSpPr txBox="1"/>
          <p:nvPr/>
        </p:nvSpPr>
        <p:spPr>
          <a:xfrm>
            <a:off x="379256" y="523330"/>
            <a:ext cx="3877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D8054D4-99F1-9A78-FF7A-9AF297CBA402}"/>
              </a:ext>
            </a:extLst>
          </p:cNvPr>
          <p:cNvSpPr txBox="1"/>
          <p:nvPr/>
        </p:nvSpPr>
        <p:spPr>
          <a:xfrm>
            <a:off x="571645" y="5545427"/>
            <a:ext cx="11590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OX4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D5C0F2A7-45BA-CCDC-B04F-C63062FD02A4}"/>
              </a:ext>
            </a:extLst>
          </p:cNvPr>
          <p:cNvSpPr/>
          <p:nvPr/>
        </p:nvSpPr>
        <p:spPr>
          <a:xfrm>
            <a:off x="2843011" y="1894930"/>
            <a:ext cx="3205092" cy="45638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54CC96BD-59C2-998D-0B7F-12BC2CF80681}"/>
              </a:ext>
            </a:extLst>
          </p:cNvPr>
          <p:cNvSpPr txBox="1"/>
          <p:nvPr/>
        </p:nvSpPr>
        <p:spPr>
          <a:xfrm>
            <a:off x="571645" y="3525558"/>
            <a:ext cx="11590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MDH2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3AE50840-E47E-FD82-DC3C-3973BCE77A28}"/>
              </a:ext>
            </a:extLst>
          </p:cNvPr>
          <p:cNvSpPr txBox="1"/>
          <p:nvPr/>
        </p:nvSpPr>
        <p:spPr>
          <a:xfrm>
            <a:off x="547261" y="7612105"/>
            <a:ext cx="11590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LaminB1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D8A0F5F4-5F58-9DDA-E61C-03E920867333}"/>
              </a:ext>
            </a:extLst>
          </p:cNvPr>
          <p:cNvSpPr/>
          <p:nvPr/>
        </p:nvSpPr>
        <p:spPr>
          <a:xfrm>
            <a:off x="2843011" y="3538248"/>
            <a:ext cx="3205092" cy="5504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1ACCBEFE-7CCB-D8D3-9BB9-24DD6AB1F1D4}"/>
              </a:ext>
            </a:extLst>
          </p:cNvPr>
          <p:cNvSpPr/>
          <p:nvPr/>
        </p:nvSpPr>
        <p:spPr>
          <a:xfrm>
            <a:off x="2778577" y="5352854"/>
            <a:ext cx="3205092" cy="5504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9F6BE07E-7359-99F7-4DE1-2D664D6E4CB4}"/>
              </a:ext>
            </a:extLst>
          </p:cNvPr>
          <p:cNvSpPr/>
          <p:nvPr/>
        </p:nvSpPr>
        <p:spPr>
          <a:xfrm>
            <a:off x="2818627" y="7560059"/>
            <a:ext cx="3205092" cy="5504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D4F43B47-821A-1413-8A27-8A5318CEDAFC}"/>
              </a:ext>
            </a:extLst>
          </p:cNvPr>
          <p:cNvSpPr txBox="1"/>
          <p:nvPr/>
        </p:nvSpPr>
        <p:spPr>
          <a:xfrm>
            <a:off x="28160" y="14717"/>
            <a:ext cx="61327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2954494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FB4B4F1-97E9-7C51-1204-B1CD858CF1A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Picture 30">
            <a:extLst>
              <a:ext uri="{FF2B5EF4-FFF2-40B4-BE49-F238E27FC236}">
                <a16:creationId xmlns:a16="http://schemas.microsoft.com/office/drawing/2014/main" id="{6F036736-98D2-E03D-BD76-D329D9C3BF4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3740" y="941430"/>
            <a:ext cx="5402327" cy="3592810"/>
          </a:xfrm>
          <a:prstGeom prst="rect">
            <a:avLst/>
          </a:prstGeom>
        </p:spPr>
      </p:pic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9A54F316-C0F0-1C79-6694-EA743F463E28}"/>
              </a:ext>
            </a:extLst>
          </p:cNvPr>
          <p:cNvSpPr txBox="1"/>
          <p:nvPr/>
        </p:nvSpPr>
        <p:spPr>
          <a:xfrm>
            <a:off x="85002" y="22873"/>
            <a:ext cx="27833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34A5756-0943-EB48-EA54-8C277E26D079}"/>
              </a:ext>
            </a:extLst>
          </p:cNvPr>
          <p:cNvSpPr txBox="1"/>
          <p:nvPr/>
        </p:nvSpPr>
        <p:spPr>
          <a:xfrm>
            <a:off x="476536" y="523330"/>
            <a:ext cx="3877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501F20CA-B43A-BB0B-7062-9BCD31C256C2}"/>
              </a:ext>
            </a:extLst>
          </p:cNvPr>
          <p:cNvSpPr/>
          <p:nvPr/>
        </p:nvSpPr>
        <p:spPr>
          <a:xfrm>
            <a:off x="1091522" y="1554462"/>
            <a:ext cx="1776860" cy="78959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CCF89ACE-79DD-48DA-1A59-89E28497F178}"/>
              </a:ext>
            </a:extLst>
          </p:cNvPr>
          <p:cNvSpPr/>
          <p:nvPr/>
        </p:nvSpPr>
        <p:spPr>
          <a:xfrm>
            <a:off x="1091522" y="2344058"/>
            <a:ext cx="1776860" cy="10388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435638D9-AD94-3EE4-FCF8-0244D6BEE3EF}"/>
              </a:ext>
            </a:extLst>
          </p:cNvPr>
          <p:cNvCxnSpPr>
            <a:cxnSpLocks/>
          </p:cNvCxnSpPr>
          <p:nvPr/>
        </p:nvCxnSpPr>
        <p:spPr>
          <a:xfrm>
            <a:off x="676015" y="1549081"/>
            <a:ext cx="6181985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A202E3B9-0FC1-1FAF-B1EC-C7C167B4110E}"/>
              </a:ext>
            </a:extLst>
          </p:cNvPr>
          <p:cNvCxnSpPr>
            <a:cxnSpLocks/>
          </p:cNvCxnSpPr>
          <p:nvPr/>
        </p:nvCxnSpPr>
        <p:spPr>
          <a:xfrm>
            <a:off x="676015" y="2344058"/>
            <a:ext cx="6181985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923C3637-D8FF-CE24-B18A-45D0865D1D2F}"/>
              </a:ext>
            </a:extLst>
          </p:cNvPr>
          <p:cNvSpPr txBox="1"/>
          <p:nvPr/>
        </p:nvSpPr>
        <p:spPr>
          <a:xfrm>
            <a:off x="6181985" y="1862765"/>
            <a:ext cx="9015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aminB1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0AC46D5E-1450-AE7A-9388-B3D1B4691D9A}"/>
              </a:ext>
            </a:extLst>
          </p:cNvPr>
          <p:cNvSpPr txBox="1"/>
          <p:nvPr/>
        </p:nvSpPr>
        <p:spPr>
          <a:xfrm>
            <a:off x="6204384" y="2568477"/>
            <a:ext cx="77283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IRT3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DH2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3386EB98-6C2F-967C-CBEE-5212C16E16A3}"/>
              </a:ext>
            </a:extLst>
          </p:cNvPr>
          <p:cNvSpPr txBox="1"/>
          <p:nvPr/>
        </p:nvSpPr>
        <p:spPr>
          <a:xfrm>
            <a:off x="6249964" y="3835135"/>
            <a:ext cx="7728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OX4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id="{C36DEE32-5C0C-D1F1-255F-458C7D757DA3}"/>
              </a:ext>
            </a:extLst>
          </p:cNvPr>
          <p:cNvSpPr/>
          <p:nvPr/>
        </p:nvSpPr>
        <p:spPr>
          <a:xfrm>
            <a:off x="1091522" y="3632376"/>
            <a:ext cx="1776860" cy="91465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27120B1C-FE7C-E7EA-3FB4-71F3201EDFF8}"/>
              </a:ext>
            </a:extLst>
          </p:cNvPr>
          <p:cNvCxnSpPr>
            <a:cxnSpLocks/>
          </p:cNvCxnSpPr>
          <p:nvPr/>
        </p:nvCxnSpPr>
        <p:spPr>
          <a:xfrm>
            <a:off x="676015" y="3382950"/>
            <a:ext cx="6181985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4788387C-AE44-E602-0D64-6ADA5F0AFF0F}"/>
              </a:ext>
            </a:extLst>
          </p:cNvPr>
          <p:cNvCxnSpPr>
            <a:cxnSpLocks/>
          </p:cNvCxnSpPr>
          <p:nvPr/>
        </p:nvCxnSpPr>
        <p:spPr>
          <a:xfrm>
            <a:off x="676015" y="4547029"/>
            <a:ext cx="6181985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" name="テキスト ボックス 20">
            <a:extLst>
              <a:ext uri="{FF2B5EF4-FFF2-40B4-BE49-F238E27FC236}">
                <a16:creationId xmlns:a16="http://schemas.microsoft.com/office/drawing/2014/main" id="{B3AE636C-D39C-4895-973F-7FDBFF8E0464}"/>
              </a:ext>
            </a:extLst>
          </p:cNvPr>
          <p:cNvSpPr txBox="1"/>
          <p:nvPr/>
        </p:nvSpPr>
        <p:spPr>
          <a:xfrm>
            <a:off x="-91776" y="1292270"/>
            <a:ext cx="11053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20">
            <a:extLst>
              <a:ext uri="{FF2B5EF4-FFF2-40B4-BE49-F238E27FC236}">
                <a16:creationId xmlns:a16="http://schemas.microsoft.com/office/drawing/2014/main" id="{55FB6B66-FB82-12B6-C009-17DE77E8A270}"/>
              </a:ext>
            </a:extLst>
          </p:cNvPr>
          <p:cNvSpPr txBox="1"/>
          <p:nvPr/>
        </p:nvSpPr>
        <p:spPr>
          <a:xfrm>
            <a:off x="-42370" y="1608061"/>
            <a:ext cx="11053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20">
            <a:extLst>
              <a:ext uri="{FF2B5EF4-FFF2-40B4-BE49-F238E27FC236}">
                <a16:creationId xmlns:a16="http://schemas.microsoft.com/office/drawing/2014/main" id="{AEE75D5D-ABA3-3809-0A39-74BBE9F93E12}"/>
              </a:ext>
            </a:extLst>
          </p:cNvPr>
          <p:cNvSpPr txBox="1"/>
          <p:nvPr/>
        </p:nvSpPr>
        <p:spPr>
          <a:xfrm>
            <a:off x="-51236" y="2127988"/>
            <a:ext cx="11053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20">
            <a:extLst>
              <a:ext uri="{FF2B5EF4-FFF2-40B4-BE49-F238E27FC236}">
                <a16:creationId xmlns:a16="http://schemas.microsoft.com/office/drawing/2014/main" id="{5D8CDAB7-CA1A-ACBC-7813-76BD572821A0}"/>
              </a:ext>
            </a:extLst>
          </p:cNvPr>
          <p:cNvSpPr txBox="1"/>
          <p:nvPr/>
        </p:nvSpPr>
        <p:spPr>
          <a:xfrm>
            <a:off x="-42370" y="2533986"/>
            <a:ext cx="11053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20">
            <a:extLst>
              <a:ext uri="{FF2B5EF4-FFF2-40B4-BE49-F238E27FC236}">
                <a16:creationId xmlns:a16="http://schemas.microsoft.com/office/drawing/2014/main" id="{894B5F9D-6045-FE75-6017-52997BB0C5A5}"/>
              </a:ext>
            </a:extLst>
          </p:cNvPr>
          <p:cNvSpPr txBox="1"/>
          <p:nvPr/>
        </p:nvSpPr>
        <p:spPr>
          <a:xfrm>
            <a:off x="-51236" y="3133525"/>
            <a:ext cx="11053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20">
            <a:extLst>
              <a:ext uri="{FF2B5EF4-FFF2-40B4-BE49-F238E27FC236}">
                <a16:creationId xmlns:a16="http://schemas.microsoft.com/office/drawing/2014/main" id="{DE75995D-30C4-0ADB-ACA2-70F040FE90A9}"/>
              </a:ext>
            </a:extLst>
          </p:cNvPr>
          <p:cNvSpPr txBox="1"/>
          <p:nvPr/>
        </p:nvSpPr>
        <p:spPr>
          <a:xfrm>
            <a:off x="-51236" y="3433295"/>
            <a:ext cx="11053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20">
            <a:extLst>
              <a:ext uri="{FF2B5EF4-FFF2-40B4-BE49-F238E27FC236}">
                <a16:creationId xmlns:a16="http://schemas.microsoft.com/office/drawing/2014/main" id="{3D707BDA-B927-2735-7D8F-DDF74504DAB0}"/>
              </a:ext>
            </a:extLst>
          </p:cNvPr>
          <p:cNvSpPr txBox="1"/>
          <p:nvPr/>
        </p:nvSpPr>
        <p:spPr>
          <a:xfrm>
            <a:off x="-51236" y="3769730"/>
            <a:ext cx="11053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20">
            <a:extLst>
              <a:ext uri="{FF2B5EF4-FFF2-40B4-BE49-F238E27FC236}">
                <a16:creationId xmlns:a16="http://schemas.microsoft.com/office/drawing/2014/main" id="{ACD3601C-7677-37EC-1829-CC56B754CC42}"/>
              </a:ext>
            </a:extLst>
          </p:cNvPr>
          <p:cNvSpPr txBox="1"/>
          <p:nvPr/>
        </p:nvSpPr>
        <p:spPr>
          <a:xfrm>
            <a:off x="-51297" y="4177695"/>
            <a:ext cx="11053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直線コネクタ 16">
            <a:extLst>
              <a:ext uri="{FF2B5EF4-FFF2-40B4-BE49-F238E27FC236}">
                <a16:creationId xmlns:a16="http://schemas.microsoft.com/office/drawing/2014/main" id="{65788FC3-069F-8C49-8A35-D12C71C0487B}"/>
              </a:ext>
            </a:extLst>
          </p:cNvPr>
          <p:cNvCxnSpPr>
            <a:cxnSpLocks/>
          </p:cNvCxnSpPr>
          <p:nvPr/>
        </p:nvCxnSpPr>
        <p:spPr>
          <a:xfrm>
            <a:off x="676015" y="3632046"/>
            <a:ext cx="6181985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168432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5185</TotalTime>
  <Words>150</Words>
  <Application>Microsoft Macintosh PowerPoint</Application>
  <PresentationFormat>A4 Paper (210x297 mm)</PresentationFormat>
  <Paragraphs>86</Paragraphs>
  <Slides>7</Slides>
  <Notes>7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游ゴシック</vt:lpstr>
      <vt:lpstr>游ゴシック Light</vt:lpstr>
      <vt:lpstr>Arial</vt:lpstr>
      <vt:lpstr>Calibri</vt:lpstr>
      <vt:lpstr>Office テーマ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Shukoh Watanabe</dc:creator>
  <cp:lastModifiedBy>大谷　結菜</cp:lastModifiedBy>
  <cp:revision>1249</cp:revision>
  <cp:lastPrinted>2024-09-13T05:43:16Z</cp:lastPrinted>
  <dcterms:created xsi:type="dcterms:W3CDTF">2015-02-27T02:56:02Z</dcterms:created>
  <dcterms:modified xsi:type="dcterms:W3CDTF">2025-06-29T03:14:07Z</dcterms:modified>
</cp:coreProperties>
</file>